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9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6" d="100"/>
          <a:sy n="86" d="100"/>
        </p:scale>
        <p:origin x="-82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3676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4249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3136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6329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247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7294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7179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5965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5993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9118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2777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974F4-721C-4EAC-BC16-E2E81A8CE721}" type="datetimeFigureOut">
              <a:rPr lang="es-ES" smtClean="0"/>
              <a:t>16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6259D-AEC1-4EBB-B3BD-94D6C0182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4111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57200" y="609600"/>
            <a:ext cx="8229600" cy="5516563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s-ES" sz="1600" b="1" dirty="0" err="1">
                <a:latin typeface="Arial" pitchFamily="34" charset="0"/>
                <a:cs typeface="Arial" pitchFamily="34" charset="0"/>
              </a:rPr>
              <a:t>Linkag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isequilibrium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patterns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populatio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structur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iversity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analysis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in a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worldwid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urum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collectio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including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Argentinia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genotypes</a:t>
            </a:r>
            <a:endParaRPr lang="es-ES" sz="1600" b="1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Pablo Federico Roncallo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Adelina Olga Larsen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Ana Laura Achilli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Carolina Saint 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Pierre</a:t>
            </a: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Cristian Andrés Gallo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Susanne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Dreisigacker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Viviana Echenique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*</a:t>
            </a: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 Centro 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de Recursos Naturales Renovables de la Zona Semiárida (CERZOS), Departamento de Agronomía, Universidad Nacional del Sur (UNS)-CONICET, Bahía Blanca, Argentina.</a:t>
            </a:r>
          </a:p>
          <a:p>
            <a:pPr marL="0" indent="0">
              <a:buNone/>
            </a:pPr>
            <a:r>
              <a:rPr lang="es-ES" sz="16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CEI Barrow, Instituto Nacional de Tecnología Agropecuaria (INTA), Tres Arroyos, Buenos Aires, Argentina. </a:t>
            </a:r>
          </a:p>
          <a:p>
            <a:pPr marL="0" indent="0">
              <a:buNone/>
            </a:pP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International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Maize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Improvement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Center (CIMMYT), El Batán, Edo. de México, México.</a:t>
            </a: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*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Corresponding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author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: </a:t>
            </a:r>
          </a:p>
          <a:p>
            <a:pPr marL="0" indent="0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E-mail: echeniq@criba.edu.ar</a:t>
            </a:r>
          </a:p>
          <a:p>
            <a:endParaRPr lang="es-ES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45124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173" y="722868"/>
            <a:ext cx="4479827" cy="27205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CuadroTexto"/>
          <p:cNvSpPr txBox="1"/>
          <p:nvPr/>
        </p:nvSpPr>
        <p:spPr>
          <a:xfrm>
            <a:off x="353704" y="392668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/>
              <a:t>a</a:t>
            </a:r>
            <a:endParaRPr lang="es-ES" b="1" dirty="0"/>
          </a:p>
        </p:txBody>
      </p:sp>
      <p:sp>
        <p:nvSpPr>
          <p:cNvPr id="12" name="11 CuadroTexto"/>
          <p:cNvSpPr txBox="1"/>
          <p:nvPr/>
        </p:nvSpPr>
        <p:spPr>
          <a:xfrm>
            <a:off x="353704" y="3440668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c</a:t>
            </a:r>
            <a:endParaRPr lang="es-ES" b="1" dirty="0"/>
          </a:p>
        </p:txBody>
      </p:sp>
      <p:sp>
        <p:nvSpPr>
          <p:cNvPr id="13" name="12 CuadroTexto"/>
          <p:cNvSpPr txBox="1"/>
          <p:nvPr/>
        </p:nvSpPr>
        <p:spPr>
          <a:xfrm>
            <a:off x="5078104" y="39266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/>
              <a:t>b</a:t>
            </a:r>
            <a:endParaRPr lang="es-ES" b="1" dirty="0"/>
          </a:p>
        </p:txBody>
      </p:sp>
      <p:sp>
        <p:nvSpPr>
          <p:cNvPr id="14" name="13 CuadroTexto"/>
          <p:cNvSpPr txBox="1"/>
          <p:nvPr/>
        </p:nvSpPr>
        <p:spPr>
          <a:xfrm>
            <a:off x="5078104" y="344066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d</a:t>
            </a:r>
            <a:endParaRPr lang="es-ES" b="1" dirty="0"/>
          </a:p>
        </p:txBody>
      </p:sp>
      <p:cxnSp>
        <p:nvCxnSpPr>
          <p:cNvPr id="17" name="16 Conector recto"/>
          <p:cNvCxnSpPr/>
          <p:nvPr/>
        </p:nvCxnSpPr>
        <p:spPr>
          <a:xfrm>
            <a:off x="461654" y="2672318"/>
            <a:ext cx="3886200" cy="0"/>
          </a:xfrm>
          <a:prstGeom prst="line">
            <a:avLst/>
          </a:prstGeom>
          <a:ln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14 Conector recto"/>
          <p:cNvCxnSpPr/>
          <p:nvPr/>
        </p:nvCxnSpPr>
        <p:spPr>
          <a:xfrm>
            <a:off x="457200" y="2870822"/>
            <a:ext cx="3886200" cy="0"/>
          </a:xfrm>
          <a:prstGeom prst="line">
            <a:avLst/>
          </a:prstGeom>
          <a:ln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8" descr="C:\Users\Pablo\Documents\LABORAL\INVESTIGACION\PUBLICACIONES\Trabajos Publicados\2020\2016 GENETIC STRUCTURE USING SNPs BMC GENOMICS\Manuscrito\BMC genomics V1\REVIEW 1\LD\PLOTS\LD PLOT whole genome ARG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6" t="1687" r="1162" b="2554"/>
          <a:stretch/>
        </p:blipFill>
        <p:spPr bwMode="auto">
          <a:xfrm>
            <a:off x="4953000" y="704088"/>
            <a:ext cx="4176666" cy="27249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9" descr="C:\Users\Pablo\Documents\LABORAL\INVESTIGACION\PUBLICACIONES\Trabajos Publicados\2020\2016 GENETIC STRUCTURE USING SNPs BMC GENOMICS\Manuscrito\BMC genomics V1\REVIEW 1\LD\PLOTS\LD PLOT A genome ARG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9" t="1686" r="1281" b="2555"/>
          <a:stretch/>
        </p:blipFill>
        <p:spPr bwMode="auto">
          <a:xfrm>
            <a:off x="381000" y="3886199"/>
            <a:ext cx="4165048" cy="27249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10" descr="C:\Users\Pablo\Documents\LABORAL\INVESTIGACION\PUBLICACIONES\Trabajos Publicados\2020\2016 GENETIC STRUCTURE USING SNPs BMC GENOMICS\Manuscrito\BMC genomics V1\REVIEW 1\LD\PLOTS\LD PLOT B genome ARG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0" t="1974" r="1281" b="1468"/>
          <a:stretch/>
        </p:blipFill>
        <p:spPr bwMode="auto">
          <a:xfrm>
            <a:off x="4996143" y="3904488"/>
            <a:ext cx="4147857" cy="27249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85491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9841" y="457200"/>
            <a:ext cx="4407959" cy="3017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241" y="457200"/>
            <a:ext cx="4407959" cy="3017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12 CuadroTexto"/>
          <p:cNvSpPr txBox="1"/>
          <p:nvPr/>
        </p:nvSpPr>
        <p:spPr>
          <a:xfrm>
            <a:off x="353704" y="39266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e</a:t>
            </a:r>
            <a:endParaRPr lang="es-ES" b="1" dirty="0"/>
          </a:p>
        </p:txBody>
      </p:sp>
      <p:sp>
        <p:nvSpPr>
          <p:cNvPr id="14" name="13 CuadroTexto"/>
          <p:cNvSpPr txBox="1"/>
          <p:nvPr/>
        </p:nvSpPr>
        <p:spPr>
          <a:xfrm>
            <a:off x="353704" y="3440668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g</a:t>
            </a:r>
            <a:endParaRPr lang="es-ES" b="1" dirty="0"/>
          </a:p>
        </p:txBody>
      </p:sp>
      <p:sp>
        <p:nvSpPr>
          <p:cNvPr id="15" name="14 CuadroTexto"/>
          <p:cNvSpPr txBox="1"/>
          <p:nvPr/>
        </p:nvSpPr>
        <p:spPr>
          <a:xfrm>
            <a:off x="5078104" y="392668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f</a:t>
            </a:r>
            <a:endParaRPr lang="es-ES" b="1" dirty="0"/>
          </a:p>
        </p:txBody>
      </p:sp>
      <p:sp>
        <p:nvSpPr>
          <p:cNvPr id="16" name="15 CuadroTexto"/>
          <p:cNvSpPr txBox="1"/>
          <p:nvPr/>
        </p:nvSpPr>
        <p:spPr>
          <a:xfrm>
            <a:off x="5078104" y="344066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b="1" dirty="0" smtClean="0"/>
              <a:t>h</a:t>
            </a:r>
            <a:endParaRPr lang="es-ES" b="1" dirty="0"/>
          </a:p>
        </p:txBody>
      </p:sp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9036" y="3724220"/>
            <a:ext cx="4497717" cy="27527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3719450"/>
            <a:ext cx="4470285" cy="2757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5 CuadroTexto"/>
          <p:cNvSpPr txBox="1"/>
          <p:nvPr/>
        </p:nvSpPr>
        <p:spPr>
          <a:xfrm>
            <a:off x="914400" y="457200"/>
            <a:ext cx="2945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P pairs in high LD (</a:t>
            </a:r>
            <a:r>
              <a:rPr lang="en-US" i="1" dirty="0"/>
              <a:t>r</a:t>
            </a:r>
            <a:r>
              <a:rPr lang="en-US" i="1" baseline="30000" dirty="0"/>
              <a:t>2</a:t>
            </a:r>
            <a:r>
              <a:rPr lang="en-US" dirty="0"/>
              <a:t> &gt; 0.7)</a:t>
            </a:r>
            <a:endParaRPr lang="es-ES" dirty="0"/>
          </a:p>
        </p:txBody>
      </p:sp>
      <p:sp>
        <p:nvSpPr>
          <p:cNvPr id="23" name="22 CuadroTexto"/>
          <p:cNvSpPr txBox="1"/>
          <p:nvPr/>
        </p:nvSpPr>
        <p:spPr>
          <a:xfrm>
            <a:off x="5569497" y="457200"/>
            <a:ext cx="3193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P pairs in complete LD (</a:t>
            </a:r>
            <a:r>
              <a:rPr lang="en-US" i="1" dirty="0"/>
              <a:t>r</a:t>
            </a:r>
            <a:r>
              <a:rPr lang="en-US" i="1" baseline="30000" dirty="0"/>
              <a:t>2</a:t>
            </a:r>
            <a:r>
              <a:rPr lang="en-US" dirty="0"/>
              <a:t> =1)</a:t>
            </a: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41077800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70</TotalTime>
  <Words>150</Words>
  <Application>Microsoft Office PowerPoint</Application>
  <PresentationFormat>Presentación en pantalla (4:3)</PresentationFormat>
  <Paragraphs>23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Company>Luff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Roncallo</dc:creator>
  <cp:lastModifiedBy>Pablo Roncallo</cp:lastModifiedBy>
  <cp:revision>31</cp:revision>
  <dcterms:created xsi:type="dcterms:W3CDTF">2020-07-30T12:57:16Z</dcterms:created>
  <dcterms:modified xsi:type="dcterms:W3CDTF">2021-02-18T00:55:46Z</dcterms:modified>
</cp:coreProperties>
</file>